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7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yan, Edward T.,M.D." initials="RET" lastIdx="7" clrIdx="0">
    <p:extLst>
      <p:ext uri="{19B8F6BF-5375-455C-9EA6-DF929625EA0E}">
        <p15:presenceInfo xmlns:p15="http://schemas.microsoft.com/office/powerpoint/2012/main" userId="S-1-5-21-8915387-943144406-1916815836-252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BA502-F328-4E76-801F-02EE2307F9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3D972F-0D2B-4935-98AB-182526A4D3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79538-F869-4B72-B3D2-EDFBD3030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A7040-C4FB-4E3B-87CE-0C5A17DC6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E004D-7F83-4670-85EB-4CC6CE156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239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978F4-695F-4F7B-A082-6C4769B67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104D9D-0A81-41F1-A212-860FA7783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51CC2-55BE-4339-B9B5-CBF940CA1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31E5F-4383-4978-9B22-C3B0BBA66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2B9E2-2D75-4C44-87B3-B69393CD8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067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3E2FAB-F728-46F2-A2EB-F32DE030E6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258111-6159-41C3-B79E-0056033B2D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ED1FE-0774-4E7C-B3F3-2169054F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3F27A-C69E-4A4D-A99E-E3655FC2B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3665A6-B42C-435E-8CDE-BEF778073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3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65138-CB44-451D-A817-366801FC8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251FC-CF00-4887-92A4-EED5243A00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BAA48-E76C-430B-B64A-B3CCD5B2C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D58D1-CCFE-4C30-9918-42D9085D5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9FA19-6B85-4913-A2F7-B7ED1A37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44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4EFA8-A4D3-4931-8FE6-DAAC8DCDD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A7BAAD-0FB3-4291-8651-7880D4861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B4443-9B10-4BAC-8048-918581CC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89B3A-FCA0-4EBA-B12D-B5F9A5DD9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4B35DB-67D2-4B5B-A41A-FD33FB63B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00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6D88E-F710-488A-9860-7D9C093F4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7EAEFA-C2F3-472A-B60C-DAE796455E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1F468C-612D-476D-9FAE-BFC8B9A74D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09373-BF63-4541-A42A-9BB188CFF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98B675-A572-4A23-867F-FB0B4DF7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0CBE6-7D4C-42DC-B5F7-F00A3157D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1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2CBBD-EBBD-43C4-8E93-D4077A6C7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11195-184A-4BA5-A9F0-9D9DCFA6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7531FF-CD52-4A08-98FF-FCE995C67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0E03D8-D93E-4C6A-82CA-311139A678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F3401A-D679-4D91-A3D6-1BFEC924F8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FD359E-598F-48C1-9919-AA4F9A618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BFA28E-DC05-4A5E-80D0-463820DA6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5DF75A-6B30-432D-8069-36B7C6081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3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81EE9-65FE-4FC5-BC37-CD61273F9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DDD91-0236-4B60-926D-72067C18A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4BE5D6-2FF5-4D5B-A6B1-82B41B79C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CF9DE8-7C6E-4F4D-8EA8-7259386AE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20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7E4491-788A-4821-9E6E-570A8CE6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B716BC-9E60-4DEA-A07B-80BD02145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D0791B-A499-45CD-8F78-DA9BE7D30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05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88561-81FB-43F0-AE7A-35A362648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83C397-50A4-4C0C-B407-0138AE86AB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B49911-E1A7-485F-8AB1-60951F9F82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B1B66C-7CBC-4C89-A559-128787994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74D22C-025D-4125-A048-33F23A3A9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55B70-97CF-4715-83C6-6ADAF3E23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2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4FC6C-F436-486E-9F5D-CB67FA0E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FC830-4DC3-4C31-8286-900695D144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0CFC38-6DC0-4B24-9B16-723421F654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46571-AE5F-4C6D-A1E8-85F1A45A7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C8367C-6D79-4E70-B7B1-590275D59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8B58E-1339-4343-8DE4-B6BFD476A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56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2B21B23-1BE5-4230-8070-F5D9436C0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53AED6-C2E9-4DA5-B4A7-73250757F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29CA7-A24A-4A68-BC90-765289BA88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8A1B4-6CAD-452C-B2DF-90DB79436B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3B7F6-D911-46CA-9FD0-EBCAED55DA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048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064A0-E636-4F00-ADAA-B8117F0F4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61896" y="1754149"/>
            <a:ext cx="7594831" cy="2668078"/>
          </a:xfrm>
        </p:spPr>
        <p:txBody>
          <a:bodyPr>
            <a:normAutofit/>
          </a:bodyPr>
          <a:lstStyle/>
          <a:p>
            <a:r>
              <a:rPr lang="en-US" b="1" dirty="0"/>
              <a:t>Supplemental Figure 3:</a:t>
            </a:r>
            <a:br>
              <a:rPr lang="en-US" b="1" dirty="0"/>
            </a:b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3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urified 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TTHc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alyzed by SE-HPLC compared with standard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TTHc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was analyzed using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SKgel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G2000SWxL column on Waters HPLC system at 25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, eluted with 10 mM sodium phosphate, 150 mM NaCl, pH 7.2) at 0.5 mL/min flow rate.</a:t>
            </a:r>
            <a:br>
              <a:rPr lang="en-US" sz="1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10485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5DD3281E-CDCE-4309-BF66-DAE1E276D08D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981327" y="2768629"/>
            <a:ext cx="4856400" cy="402120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11BAB9EE-3FEF-4244-B4A4-8D16D7D618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00" y="2803374"/>
            <a:ext cx="4856922" cy="4020483"/>
          </a:xfrm>
          <a:prstGeom prst="rect">
            <a:avLst/>
          </a:prstGeom>
        </p:spPr>
      </p:pic>
      <p:graphicFrame>
        <p:nvGraphicFramePr>
          <p:cNvPr id="13" name="표 16">
            <a:extLst>
              <a:ext uri="{FF2B5EF4-FFF2-40B4-BE49-F238E27FC236}">
                <a16:creationId xmlns:a16="http://schemas.microsoft.com/office/drawing/2014/main" id="{7016FB76-B477-4CF4-8F03-AECC4A779759}"/>
              </a:ext>
            </a:extLst>
          </p:cNvPr>
          <p:cNvGraphicFramePr>
            <a:graphicFrameLocks noGrp="1"/>
          </p:cNvGraphicFramePr>
          <p:nvPr/>
        </p:nvGraphicFramePr>
        <p:xfrm>
          <a:off x="5465254" y="1192727"/>
          <a:ext cx="5888546" cy="1112520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648018">
                  <a:extLst>
                    <a:ext uri="{9D8B030D-6E8A-4147-A177-3AD203B41FA5}">
                      <a16:colId xmlns:a16="http://schemas.microsoft.com/office/drawing/2014/main" val="2041966198"/>
                    </a:ext>
                  </a:extLst>
                </a:gridCol>
                <a:gridCol w="3641979">
                  <a:extLst>
                    <a:ext uri="{9D8B030D-6E8A-4147-A177-3AD203B41FA5}">
                      <a16:colId xmlns:a16="http://schemas.microsoft.com/office/drawing/2014/main" val="2783987787"/>
                    </a:ext>
                  </a:extLst>
                </a:gridCol>
                <a:gridCol w="1598549">
                  <a:extLst>
                    <a:ext uri="{9D8B030D-6E8A-4147-A177-3AD203B41FA5}">
                      <a16:colId xmlns:a16="http://schemas.microsoft.com/office/drawing/2014/main" val="288728492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/>
                        <a:t>No.</a:t>
                      </a:r>
                      <a:endParaRPr lang="ko-KR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/>
                        <a:t>Sample Name</a:t>
                      </a:r>
                      <a:endParaRPr lang="ko-KR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/>
                        <a:t>Injection vol.</a:t>
                      </a:r>
                      <a:endParaRPr lang="ko-KR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30624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/>
                        <a:t>1</a:t>
                      </a:r>
                      <a:endParaRPr lang="ko-KR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dirty="0"/>
                        <a:t>rTTHC-P2001 Final pool</a:t>
                      </a:r>
                      <a:endParaRPr lang="ko-KR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/>
                        <a:t>20ul</a:t>
                      </a:r>
                      <a:endParaRPr lang="ko-KR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02572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/>
                        <a:t>2</a:t>
                      </a:r>
                      <a:endParaRPr lang="ko-KR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dirty="0"/>
                        <a:t>Standard 1.3mg/mL </a:t>
                      </a:r>
                      <a:endParaRPr lang="ko-KR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/>
                        <a:t>20ul</a:t>
                      </a:r>
                      <a:endParaRPr lang="ko-KR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4070333"/>
                  </a:ext>
                </a:extLst>
              </a:tr>
            </a:tbl>
          </a:graphicData>
        </a:graphic>
      </p:graphicFrame>
      <p:sp>
        <p:nvSpPr>
          <p:cNvPr id="14" name="제목 3">
            <a:extLst>
              <a:ext uri="{FF2B5EF4-FFF2-40B4-BE49-F238E27FC236}">
                <a16:creationId xmlns:a16="http://schemas.microsoft.com/office/drawing/2014/main" id="{D7E38617-E863-4577-B2F9-CA81BDCD86D5}"/>
              </a:ext>
            </a:extLst>
          </p:cNvPr>
          <p:cNvSpPr txBox="1">
            <a:spLocks/>
          </p:cNvSpPr>
          <p:nvPr/>
        </p:nvSpPr>
        <p:spPr>
          <a:xfrm>
            <a:off x="322127" y="210594"/>
            <a:ext cx="10515600" cy="64692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rTTHC-P2001 by SE-HPLC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F158A7D2-95E7-4352-985C-4A19ABCF819B}"/>
              </a:ext>
            </a:extLst>
          </p:cNvPr>
          <p:cNvGraphicFramePr>
            <a:graphicFrameLocks noGrp="1"/>
          </p:cNvGraphicFramePr>
          <p:nvPr/>
        </p:nvGraphicFramePr>
        <p:xfrm>
          <a:off x="838200" y="1012054"/>
          <a:ext cx="3994726" cy="17678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232000">
                  <a:extLst>
                    <a:ext uri="{9D8B030D-6E8A-4147-A177-3AD203B41FA5}">
                      <a16:colId xmlns:a16="http://schemas.microsoft.com/office/drawing/2014/main" val="1010801845"/>
                    </a:ext>
                  </a:extLst>
                </a:gridCol>
                <a:gridCol w="1762726">
                  <a:extLst>
                    <a:ext uri="{9D8B030D-6E8A-4147-A177-3AD203B41FA5}">
                      <a16:colId xmlns:a16="http://schemas.microsoft.com/office/drawing/2014/main" val="3437579745"/>
                    </a:ext>
                  </a:extLst>
                </a:gridCol>
              </a:tblGrid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Analytical column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</a:rPr>
                        <a:t>TSKgel</a:t>
                      </a:r>
                      <a:r>
                        <a:rPr lang="en-US" sz="1400" u="none" strike="noStrike" dirty="0">
                          <a:effectLst/>
                        </a:rPr>
                        <a:t> G2000SW</a:t>
                      </a:r>
                      <a:r>
                        <a:rPr lang="en-US" sz="1400" u="none" strike="noStrike" baseline="-25000" dirty="0">
                          <a:effectLst/>
                        </a:rPr>
                        <a:t>X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130448753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Guard column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</a:rPr>
                        <a:t>TSKgel</a:t>
                      </a:r>
                      <a:r>
                        <a:rPr lang="en-US" sz="1400" u="none" strike="noStrike" dirty="0">
                          <a:effectLst/>
                        </a:rPr>
                        <a:t> SW</a:t>
                      </a:r>
                      <a:r>
                        <a:rPr lang="en-US" sz="1400" u="none" strike="noStrike" baseline="-25000" dirty="0">
                          <a:effectLst/>
                        </a:rPr>
                        <a:t>X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667163817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Injection volume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20 u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678927213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Run time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40 mi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28046377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Flow rate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0.5 mL/mi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531553483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Detector Wavelength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280nm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934349049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Column Temperate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400" u="none" strike="noStrike" dirty="0">
                          <a:effectLst/>
                        </a:rPr>
                        <a:t>25 ℃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439426145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marL="285750" indent="-2857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400" u="none" strike="noStrike" dirty="0">
                          <a:effectLst/>
                        </a:rPr>
                        <a:t>Sampler Temperate: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400" u="none" strike="noStrike" dirty="0">
                          <a:effectLst/>
                        </a:rPr>
                        <a:t>15 ℃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6535716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D30756DB-0A99-446D-8016-F1439B6721E8}"/>
              </a:ext>
            </a:extLst>
          </p:cNvPr>
          <p:cNvSpPr txBox="1"/>
          <p:nvPr/>
        </p:nvSpPr>
        <p:spPr>
          <a:xfrm>
            <a:off x="3781906" y="2919640"/>
            <a:ext cx="17139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err="1">
                <a:solidFill>
                  <a:srgbClr val="FF0000"/>
                </a:solidFill>
              </a:rPr>
              <a:t>rTTHc</a:t>
            </a:r>
            <a:r>
              <a:rPr lang="en-US" altLang="ko-KR" b="1" dirty="0">
                <a:solidFill>
                  <a:srgbClr val="FF0000"/>
                </a:solidFill>
              </a:rPr>
              <a:t> standard </a:t>
            </a:r>
          </a:p>
          <a:p>
            <a:r>
              <a:rPr lang="en-US" altLang="ko-KR" b="1" dirty="0">
                <a:solidFill>
                  <a:srgbClr val="FF0000"/>
                </a:solidFill>
              </a:rPr>
              <a:t>Purity 96%</a:t>
            </a:r>
            <a:endParaRPr lang="ko-KR" altLang="en-US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DE8CCAF-EA1B-446C-A6B8-A70AF45CAEF3}"/>
              </a:ext>
            </a:extLst>
          </p:cNvPr>
          <p:cNvSpPr txBox="1"/>
          <p:nvPr/>
        </p:nvSpPr>
        <p:spPr>
          <a:xfrm>
            <a:off x="9157033" y="2919640"/>
            <a:ext cx="14009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solidFill>
                  <a:srgbClr val="FF0000"/>
                </a:solidFill>
              </a:rPr>
              <a:t>rTTHc-P2001</a:t>
            </a:r>
          </a:p>
          <a:p>
            <a:r>
              <a:rPr lang="en-US" altLang="ko-KR" b="1" dirty="0">
                <a:solidFill>
                  <a:srgbClr val="FF0000"/>
                </a:solidFill>
              </a:rPr>
              <a:t>Purity 99%</a:t>
            </a:r>
            <a:endParaRPr lang="ko-KR" altLang="en-US" b="1" dirty="0">
              <a:solidFill>
                <a:srgbClr val="FF0000"/>
              </a:solidFill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FFAD89A-996D-451A-ACF5-1D25932769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8698" y="6275063"/>
            <a:ext cx="2562588" cy="548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3254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0</TotalTime>
  <Words>127</Words>
  <Application>Microsoft Office PowerPoint</Application>
  <PresentationFormat>Widescreen</PresentationFormat>
  <Paragraphs>3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Theme</vt:lpstr>
      <vt:lpstr>Supplemental Figure 3: Figure S3. Purified rTTHc analyzed by SE-HPLC compared with standard. rTTHc was analyzed using TSKgel G2000SWxL column on Waters HPLC system at 25C, eluted with 10 mM sodium phosphate, 150 mM NaCl, pH 7.2) at 0.5 mL/min flow rate.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y, Meagan</dc:creator>
  <cp:lastModifiedBy>Ryan, Edward T.,M.D.</cp:lastModifiedBy>
  <cp:revision>68</cp:revision>
  <cp:lastPrinted>2021-06-03T18:55:09Z</cp:lastPrinted>
  <dcterms:created xsi:type="dcterms:W3CDTF">2020-08-13T18:26:36Z</dcterms:created>
  <dcterms:modified xsi:type="dcterms:W3CDTF">2021-10-19T17:28:03Z</dcterms:modified>
</cp:coreProperties>
</file>